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23427C3-B2A7-84D9-51DC-6DE942584E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37010"/>
          <a:stretch/>
        </p:blipFill>
        <p:spPr>
          <a:xfrm>
            <a:off x="1883788" y="816303"/>
            <a:ext cx="2075065" cy="237768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E98C5D7-6AD9-E4C9-6658-BEE6CC69603B}"/>
              </a:ext>
            </a:extLst>
          </p:cNvPr>
          <p:cNvSpPr txBox="1"/>
          <p:nvPr/>
        </p:nvSpPr>
        <p:spPr>
          <a:xfrm>
            <a:off x="2421744" y="3193984"/>
            <a:ext cx="8654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>
                <a:solidFill>
                  <a:schemeClr val="bg1"/>
                </a:solidFill>
                <a:highlight>
                  <a:srgbClr val="8B2F63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Hu-CD34+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9F93C03-102A-D1DF-210F-CA64819E91A8}"/>
              </a:ext>
            </a:extLst>
          </p:cNvPr>
          <p:cNvSpPr txBox="1"/>
          <p:nvPr/>
        </p:nvSpPr>
        <p:spPr>
          <a:xfrm>
            <a:off x="3195885" y="3193984"/>
            <a:ext cx="5738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>
                <a:highlight>
                  <a:srgbClr val="F5B13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NSG 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4059CD42-3A1C-82E6-93A8-2BBE9C971A31}"/>
              </a:ext>
            </a:extLst>
          </p:cNvPr>
          <p:cNvCxnSpPr>
            <a:cxnSpLocks/>
          </p:cNvCxnSpPr>
          <p:nvPr/>
        </p:nvCxnSpPr>
        <p:spPr>
          <a:xfrm>
            <a:off x="2828724" y="1214109"/>
            <a:ext cx="1025237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DC9C5C9-1A32-A9BA-305E-3278235A8824}"/>
              </a:ext>
            </a:extLst>
          </p:cNvPr>
          <p:cNvSpPr txBox="1"/>
          <p:nvPr/>
        </p:nvSpPr>
        <p:spPr>
          <a:xfrm>
            <a:off x="3135730" y="1013433"/>
            <a:ext cx="139045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/>
              <a:t>**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407F79A-1763-2E24-E8FD-F8C57196E02E}"/>
              </a:ext>
            </a:extLst>
          </p:cNvPr>
          <p:cNvSpPr txBox="1"/>
          <p:nvPr/>
        </p:nvSpPr>
        <p:spPr>
          <a:xfrm rot="16200000">
            <a:off x="853414" y="1992817"/>
            <a:ext cx="2163804" cy="238527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algn="ctr"/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serum TGF</a:t>
            </a:r>
            <a:r>
              <a:rPr lang="el-GR" sz="1100" b="1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1 conc(</a:t>
            </a:r>
            <a:r>
              <a:rPr lang="en-US" sz="1100" b="1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l-GR" sz="1100" b="1">
                <a:latin typeface="Arial" panose="020B0604020202020204" pitchFamily="34" charset="0"/>
                <a:cs typeface="Arial" panose="020B0604020202020204" pitchFamily="34" charset="0"/>
              </a:rPr>
              <a:t>ϻ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4EAA02-C0BC-2CCD-A136-5288C2A0A89A}"/>
              </a:ext>
            </a:extLst>
          </p:cNvPr>
          <p:cNvSpPr txBox="1"/>
          <p:nvPr/>
        </p:nvSpPr>
        <p:spPr>
          <a:xfrm>
            <a:off x="178196" y="3694591"/>
            <a:ext cx="650160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Figure S9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. </a:t>
            </a:r>
            <a:r>
              <a:rPr lang="en-US" sz="11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TGF</a:t>
            </a:r>
            <a:r>
              <a:rPr lang="el-GR" sz="11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β</a:t>
            </a:r>
            <a:r>
              <a:rPr lang="en-US" sz="11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1 levels are increased in an immunocompetent mouse model of Ewing sarcoma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.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omparison of TGF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1 levels in the serum of humanized and NSG mice at time of euthanasia. **=p- value &lt;0.01.  Unpaired t-test was performed for statistical analysis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rror bars represent standard deviation. 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2075700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72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3:52Z</dcterms:modified>
</cp:coreProperties>
</file>